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sldIdLst>
    <p:sldId id="329" r:id="rId3"/>
    <p:sldId id="306" r:id="rId4"/>
    <p:sldId id="324" r:id="rId5"/>
    <p:sldId id="318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uan Paul (SciM)" initials="EP(" lastIdx="2" clrIdx="0">
    <p:extLst>
      <p:ext uri="{19B8F6BF-5375-455C-9EA6-DF929625EA0E}">
        <p15:presenceInfo xmlns:p15="http://schemas.microsoft.com/office/powerpoint/2012/main" userId="S::Euan.Paul@scimentum.com::c510fca2-b33a-4a7f-908e-c2f7784cbe1a" providerId="AD"/>
      </p:ext>
    </p:extLst>
  </p:cmAuthor>
  <p:cmAuthor id="2" name="Bhavika Modasia (AS)" initials="BM(" lastIdx="2" clrIdx="1">
    <p:extLst>
      <p:ext uri="{19B8F6BF-5375-455C-9EA6-DF929625EA0E}">
        <p15:presenceInfo xmlns:p15="http://schemas.microsoft.com/office/powerpoint/2012/main" userId="S::Bhavika.Modasia@articulatescience.com::719688e0-6762-4182-ae60-121ce8c0da4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3150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commentAuthors" Target="comment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Q405'!$I$2</c:f>
              <c:strCache>
                <c:ptCount val="1"/>
                <c:pt idx="0">
                  <c:v>Little impact (bottom 2)</c:v>
                </c:pt>
              </c:strCache>
            </c:strRef>
          </c:tx>
          <c:spPr>
            <a:solidFill>
              <a:schemeClr val="accent2">
                <a:tint val="65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CED-477C-B95F-C66A28FE7881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CED-477C-B95F-C66A28FE7881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CED-477C-B95F-C66A28FE7881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CED-477C-B95F-C66A28FE7881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6CED-477C-B95F-C66A28FE7881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6CED-477C-B95F-C66A28FE7881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6CED-477C-B95F-C66A28FE7881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6CED-477C-B95F-C66A28FE7881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6CED-477C-B95F-C66A28FE7881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6CED-477C-B95F-C66A28FE788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Q405'!$G$3:$H$16</c:f>
              <c:multiLvlStrCache>
                <c:ptCount val="14"/>
                <c:lvl>
                  <c:pt idx="0">
                    <c:v>PwO</c:v>
                  </c:pt>
                  <c:pt idx="1">
                    <c:v>HCP</c:v>
                  </c:pt>
                  <c:pt idx="3">
                    <c:v>PwO</c:v>
                  </c:pt>
                  <c:pt idx="4">
                    <c:v>HCP</c:v>
                  </c:pt>
                  <c:pt idx="6">
                    <c:v>PwO</c:v>
                  </c:pt>
                  <c:pt idx="7">
                    <c:v>HCP</c:v>
                  </c:pt>
                  <c:pt idx="9">
                    <c:v>PwO</c:v>
                  </c:pt>
                  <c:pt idx="10">
                    <c:v>HCP</c:v>
                  </c:pt>
                  <c:pt idx="12">
                    <c:v>PwO</c:v>
                  </c:pt>
                  <c:pt idx="13">
                    <c:v>HCP</c:v>
                  </c:pt>
                </c:lvl>
                <c:lvl>
                  <c:pt idx="0">
                    <c:v>Obesity</c:v>
                  </c:pt>
                  <c:pt idx="3">
                    <c:v>Stroke</c:v>
                  </c:pt>
                  <c:pt idx="6">
                    <c:v>Diabetes</c:v>
                  </c:pt>
                  <c:pt idx="9">
                    <c:v>Cancer</c:v>
                  </c:pt>
                  <c:pt idx="12">
                    <c:v>COPD</c:v>
                  </c:pt>
                </c:lvl>
              </c:multiLvlStrCache>
            </c:multiLvlStrRef>
          </c:cat>
          <c:val>
            <c:numRef>
              <c:f>'Q405'!$I$3:$I$16</c:f>
              <c:numCache>
                <c:formatCode>General</c:formatCode>
                <c:ptCount val="14"/>
                <c:pt idx="0">
                  <c:v>5</c:v>
                </c:pt>
                <c:pt idx="1">
                  <c:v>1</c:v>
                </c:pt>
                <c:pt idx="3">
                  <c:v>8</c:v>
                </c:pt>
                <c:pt idx="4">
                  <c:v>1</c:v>
                </c:pt>
                <c:pt idx="6">
                  <c:v>6</c:v>
                </c:pt>
                <c:pt idx="7">
                  <c:v>1</c:v>
                </c:pt>
                <c:pt idx="9">
                  <c:v>12</c:v>
                </c:pt>
                <c:pt idx="10">
                  <c:v>1</c:v>
                </c:pt>
                <c:pt idx="12">
                  <c:v>11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6CED-477C-B95F-C66A28FE7881}"/>
            </c:ext>
          </c:extLst>
        </c:ser>
        <c:ser>
          <c:idx val="1"/>
          <c:order val="1"/>
          <c:tx>
            <c:strRef>
              <c:f>'Q405'!$J$2</c:f>
              <c:strCache>
                <c:ptCount val="1"/>
                <c:pt idx="0">
                  <c:v>Neutral/some impact (middle 1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6-6CED-477C-B95F-C66A28FE7881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8-6CED-477C-B95F-C66A28FE7881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A-6CED-477C-B95F-C66A28FE7881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C-6CED-477C-B95F-C66A28FE7881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E-6CED-477C-B95F-C66A28FE7881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0-6CED-477C-B95F-C66A28FE7881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2-6CED-477C-B95F-C66A28FE7881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4-6CED-477C-B95F-C66A28FE7881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6-6CED-477C-B95F-C66A28FE7881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8-6CED-477C-B95F-C66A28FE788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Q405'!$G$3:$H$16</c:f>
              <c:multiLvlStrCache>
                <c:ptCount val="14"/>
                <c:lvl>
                  <c:pt idx="0">
                    <c:v>PwO</c:v>
                  </c:pt>
                  <c:pt idx="1">
                    <c:v>HCP</c:v>
                  </c:pt>
                  <c:pt idx="3">
                    <c:v>PwO</c:v>
                  </c:pt>
                  <c:pt idx="4">
                    <c:v>HCP</c:v>
                  </c:pt>
                  <c:pt idx="6">
                    <c:v>PwO</c:v>
                  </c:pt>
                  <c:pt idx="7">
                    <c:v>HCP</c:v>
                  </c:pt>
                  <c:pt idx="9">
                    <c:v>PwO</c:v>
                  </c:pt>
                  <c:pt idx="10">
                    <c:v>HCP</c:v>
                  </c:pt>
                  <c:pt idx="12">
                    <c:v>PwO</c:v>
                  </c:pt>
                  <c:pt idx="13">
                    <c:v>HCP</c:v>
                  </c:pt>
                </c:lvl>
                <c:lvl>
                  <c:pt idx="0">
                    <c:v>Obesity</c:v>
                  </c:pt>
                  <c:pt idx="3">
                    <c:v>Stroke</c:v>
                  </c:pt>
                  <c:pt idx="6">
                    <c:v>Diabetes</c:v>
                  </c:pt>
                  <c:pt idx="9">
                    <c:v>Cancer</c:v>
                  </c:pt>
                  <c:pt idx="12">
                    <c:v>COPD</c:v>
                  </c:pt>
                </c:lvl>
              </c:multiLvlStrCache>
            </c:multiLvlStrRef>
          </c:cat>
          <c:val>
            <c:numRef>
              <c:f>'Q405'!$J$3:$J$16</c:f>
              <c:numCache>
                <c:formatCode>General</c:formatCode>
                <c:ptCount val="14"/>
                <c:pt idx="0">
                  <c:v>15</c:v>
                </c:pt>
                <c:pt idx="1">
                  <c:v>13</c:v>
                </c:pt>
                <c:pt idx="3">
                  <c:v>10</c:v>
                </c:pt>
                <c:pt idx="4">
                  <c:v>6</c:v>
                </c:pt>
                <c:pt idx="6">
                  <c:v>13</c:v>
                </c:pt>
                <c:pt idx="7">
                  <c:v>10</c:v>
                </c:pt>
                <c:pt idx="9">
                  <c:v>13</c:v>
                </c:pt>
                <c:pt idx="10">
                  <c:v>8</c:v>
                </c:pt>
                <c:pt idx="12">
                  <c:v>14</c:v>
                </c:pt>
                <c:pt idx="13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9-6CED-477C-B95F-C66A28FE7881}"/>
            </c:ext>
          </c:extLst>
        </c:ser>
        <c:ser>
          <c:idx val="2"/>
          <c:order val="2"/>
          <c:tx>
            <c:strRef>
              <c:f>'Q405'!$K$2</c:f>
              <c:strCache>
                <c:ptCount val="1"/>
                <c:pt idx="0">
                  <c:v>Large impact (top 2)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6CED-477C-B95F-C66A28FE7881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6CED-477C-B95F-C66A28FE7881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6CED-477C-B95F-C66A28FE7881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6CED-477C-B95F-C66A28FE7881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6CED-477C-B95F-C66A28FE7881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6CED-477C-B95F-C66A28FE7881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6CED-477C-B95F-C66A28FE7881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9-6CED-477C-B95F-C66A28FE7881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B-6CED-477C-B95F-C66A28FE7881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D-6CED-477C-B95F-C66A28FE788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Q405'!$G$3:$H$16</c:f>
              <c:multiLvlStrCache>
                <c:ptCount val="14"/>
                <c:lvl>
                  <c:pt idx="0">
                    <c:v>PwO</c:v>
                  </c:pt>
                  <c:pt idx="1">
                    <c:v>HCP</c:v>
                  </c:pt>
                  <c:pt idx="3">
                    <c:v>PwO</c:v>
                  </c:pt>
                  <c:pt idx="4">
                    <c:v>HCP</c:v>
                  </c:pt>
                  <c:pt idx="6">
                    <c:v>PwO</c:v>
                  </c:pt>
                  <c:pt idx="7">
                    <c:v>HCP</c:v>
                  </c:pt>
                  <c:pt idx="9">
                    <c:v>PwO</c:v>
                  </c:pt>
                  <c:pt idx="10">
                    <c:v>HCP</c:v>
                  </c:pt>
                  <c:pt idx="12">
                    <c:v>PwO</c:v>
                  </c:pt>
                  <c:pt idx="13">
                    <c:v>HCP</c:v>
                  </c:pt>
                </c:lvl>
                <c:lvl>
                  <c:pt idx="0">
                    <c:v>Obesity</c:v>
                  </c:pt>
                  <c:pt idx="3">
                    <c:v>Stroke</c:v>
                  </c:pt>
                  <c:pt idx="6">
                    <c:v>Diabetes</c:v>
                  </c:pt>
                  <c:pt idx="9">
                    <c:v>Cancer</c:v>
                  </c:pt>
                  <c:pt idx="12">
                    <c:v>COPD</c:v>
                  </c:pt>
                </c:lvl>
              </c:multiLvlStrCache>
            </c:multiLvlStrRef>
          </c:cat>
          <c:val>
            <c:numRef>
              <c:f>'Q405'!$K$3:$K$16</c:f>
              <c:numCache>
                <c:formatCode>General</c:formatCode>
                <c:ptCount val="14"/>
                <c:pt idx="0">
                  <c:v>80</c:v>
                </c:pt>
                <c:pt idx="1">
                  <c:v>86</c:v>
                </c:pt>
                <c:pt idx="3">
                  <c:v>82</c:v>
                </c:pt>
                <c:pt idx="4">
                  <c:v>93</c:v>
                </c:pt>
                <c:pt idx="6">
                  <c:v>81</c:v>
                </c:pt>
                <c:pt idx="7">
                  <c:v>89</c:v>
                </c:pt>
                <c:pt idx="9">
                  <c:v>75</c:v>
                </c:pt>
                <c:pt idx="10">
                  <c:v>91</c:v>
                </c:pt>
                <c:pt idx="12">
                  <c:v>75</c:v>
                </c:pt>
                <c:pt idx="13">
                  <c:v>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E-6CED-477C-B95F-C66A28FE7881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50"/>
        <c:overlap val="100"/>
        <c:axId val="556583624"/>
        <c:axId val="556583952"/>
      </c:barChart>
      <c:catAx>
        <c:axId val="5565836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56583952"/>
        <c:crosses val="autoZero"/>
        <c:auto val="1"/>
        <c:lblAlgn val="ctr"/>
        <c:lblOffset val="100"/>
        <c:tickLblSkip val="10"/>
        <c:tickMarkSkip val="10"/>
        <c:noMultiLvlLbl val="0"/>
      </c:catAx>
      <c:valAx>
        <c:axId val="55658395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658362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63608411514496332"/>
          <c:y val="6.380837521072813E-2"/>
          <c:w val="0.27709605120771691"/>
          <c:h val="0.89467466394145079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6"/>
            </a:solidFill>
            <a:ln w="952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16F-4595-962C-91CB2B39A74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16F-4595-962C-91CB2B39A74A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16F-4595-962C-91CB2B39A74A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16F-4595-962C-91CB2B39A74A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816F-4595-962C-91CB2B39A74A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816F-4595-962C-91CB2B39A74A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816F-4595-962C-91CB2B39A74A}"/>
              </c:ext>
            </c:extLst>
          </c:dPt>
          <c:dPt>
            <c:idx val="21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816F-4595-962C-91CB2B39A74A}"/>
              </c:ext>
            </c:extLst>
          </c:dPt>
          <c:dPt>
            <c:idx val="24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816F-4595-962C-91CB2B39A74A}"/>
              </c:ext>
            </c:extLst>
          </c:dPt>
          <c:dPt>
            <c:idx val="27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816F-4595-962C-91CB2B39A74A}"/>
              </c:ext>
            </c:extLst>
          </c:dPt>
          <c:dPt>
            <c:idx val="30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816F-4595-962C-91CB2B39A74A}"/>
              </c:ext>
            </c:extLst>
          </c:dPt>
          <c:dPt>
            <c:idx val="33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816F-4595-962C-91CB2B39A74A}"/>
              </c:ext>
            </c:extLst>
          </c:dPt>
          <c:dPt>
            <c:idx val="36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816F-4595-962C-91CB2B39A74A}"/>
              </c:ext>
            </c:extLst>
          </c:dPt>
          <c:dPt>
            <c:idx val="39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816F-4595-962C-91CB2B39A74A}"/>
              </c:ext>
            </c:extLst>
          </c:dPt>
          <c:dPt>
            <c:idx val="42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816F-4595-962C-91CB2B39A74A}"/>
              </c:ext>
            </c:extLst>
          </c:dPt>
          <c:dPt>
            <c:idx val="45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816F-4595-962C-91CB2B39A74A}"/>
              </c:ext>
            </c:extLst>
          </c:dPt>
          <c:dPt>
            <c:idx val="48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816F-4595-962C-91CB2B39A74A}"/>
              </c:ext>
            </c:extLst>
          </c:dPt>
          <c:dPt>
            <c:idx val="51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816F-4595-962C-91CB2B39A74A}"/>
              </c:ext>
            </c:extLst>
          </c:dPt>
          <c:dPt>
            <c:idx val="54"/>
            <c:invertIfNegative val="0"/>
            <c:bubble3D val="0"/>
            <c:spPr>
              <a:solidFill>
                <a:schemeClr val="accent2"/>
              </a:solidFill>
              <a:ln w="952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816F-4595-962C-91CB2B39A74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ppl Figure 8_14112019'!$B$3:$B$60</c:f>
              <c:strCache>
                <c:ptCount val="58"/>
                <c:pt idx="0">
                  <c:v>I believe it is my responsibility to manage my weight</c:v>
                </c:pt>
                <c:pt idx="1">
                  <c:v>I believe it is the patient’s responsibility to manage their weight</c:v>
                </c:pt>
                <c:pt idx="3">
                  <c:v>I already know what I need to do to manage my weight</c:v>
                </c:pt>
                <c:pt idx="4">
                  <c:v>Patient already knows what he/she needs to do to manage their weight</c:v>
                </c:pt>
                <c:pt idx="6">
                  <c:v>I do not feel motivated to lose weight</c:v>
                </c:pt>
                <c:pt idx="7">
                  <c:v>Patient does not feel motivated to lose weight</c:v>
                </c:pt>
                <c:pt idx="9">
                  <c:v>I do not have the financial means to support a weight loss effort</c:v>
                </c:pt>
                <c:pt idx="10">
                  <c:v>Patient does not have financial means to support a weight loss effort</c:v>
                </c:pt>
                <c:pt idx="12">
                  <c:v>Even if I were to lose weight, I would just gain it back</c:v>
                </c:pt>
                <c:pt idx="13">
                  <c:v>Even if the patient were to lose weight, he/she would just gain it back</c:v>
                </c:pt>
                <c:pt idx="15">
                  <c:v>I do not think my healthcare provider is interested/concerned about my weight</c:v>
                </c:pt>
                <c:pt idx="16">
                  <c:v>I am not interested enough in/concerned enough about patients’ weight</c:v>
                </c:pt>
                <c:pt idx="18">
                  <c:v>The appointment is not long enough/I’m rushed</c:v>
                </c:pt>
                <c:pt idx="19">
                  <c:v>The appointment is not long enough/I’m rushed</c:v>
                </c:pt>
                <c:pt idx="21">
                  <c:v>I do not trust and/or do not have a close relationship with my healthcare provider</c:v>
                </c:pt>
                <c:pt idx="22">
                  <c:v>I do not trust and/or do not have a close relationship with my patient</c:v>
                </c:pt>
                <c:pt idx="24">
                  <c:v>There are more important health issues/concerns to discuss</c:v>
                </c:pt>
                <c:pt idx="25">
                  <c:v>There are more important health issues/concerns to discuss</c:v>
                </c:pt>
                <c:pt idx="27">
                  <c:v>I do not believe I am able to lose weight</c:v>
                </c:pt>
                <c:pt idx="28">
                  <c:v>Patient does not believe he/she is able to lose weight</c:v>
                </c:pt>
                <c:pt idx="30">
                  <c:v>I do not feel comfortable bringing it up</c:v>
                </c:pt>
                <c:pt idx="31">
                  <c:v>I do not feel comfortable bringing it up</c:v>
                </c:pt>
                <c:pt idx="33">
                  <c:v>I do not see my weight as a significant medical issue</c:v>
                </c:pt>
                <c:pt idx="34">
                  <c:v>I do not see weight as a significant medical issue</c:v>
                </c:pt>
                <c:pt idx="36">
                  <c:v>My healthcare provider's office is not set up to treat patients with excess weight/obesity</c:v>
                </c:pt>
                <c:pt idx="37">
                  <c:v>My office is not set up to treat overweight patients</c:v>
                </c:pt>
                <c:pt idx="39">
                  <c:v>I am in good health and do not have weight-related health problems</c:v>
                </c:pt>
                <c:pt idx="40">
                  <c:v>Patient is in good health and does not have weight-related comorbidities</c:v>
                </c:pt>
                <c:pt idx="42">
                  <c:v>Other</c:v>
                </c:pt>
                <c:pt idx="43">
                  <c:v>Other</c:v>
                </c:pt>
                <c:pt idx="45">
                  <c:v>My healthcare provider does not have training to provide weight management services</c:v>
                </c:pt>
                <c:pt idx="46">
                  <c:v>I do not have training to provide weight management services</c:v>
                </c:pt>
                <c:pt idx="48">
                  <c:v>I have had previous bad experience discussing weight with a healthcare provider</c:v>
                </c:pt>
                <c:pt idx="49">
                  <c:v>I have had previous bad experience discussing weight with a patient</c:v>
                </c:pt>
                <c:pt idx="51">
                  <c:v>I am not interested in losing weight</c:v>
                </c:pt>
                <c:pt idx="52">
                  <c:v>Patient is not interested in losing weight</c:v>
                </c:pt>
                <c:pt idx="54">
                  <c:v>There is nothing my healthcare provider can do to help me manage my weight</c:v>
                </c:pt>
                <c:pt idx="55">
                  <c:v>There is nothing I can do to help patients managing their weight</c:v>
                </c:pt>
                <c:pt idx="57">
                  <c:v>I do not get financial compensation for treating obesity</c:v>
                </c:pt>
              </c:strCache>
            </c:strRef>
          </c:cat>
          <c:val>
            <c:numRef>
              <c:f>'Suppl Figure 8_14112019'!$C$3:$C$60</c:f>
              <c:numCache>
                <c:formatCode>General</c:formatCode>
                <c:ptCount val="58"/>
                <c:pt idx="0">
                  <c:v>42</c:v>
                </c:pt>
                <c:pt idx="1">
                  <c:v>6</c:v>
                </c:pt>
                <c:pt idx="3">
                  <c:v>24</c:v>
                </c:pt>
                <c:pt idx="4">
                  <c:v>25</c:v>
                </c:pt>
                <c:pt idx="6">
                  <c:v>22</c:v>
                </c:pt>
                <c:pt idx="7">
                  <c:v>75</c:v>
                </c:pt>
                <c:pt idx="9">
                  <c:v>22</c:v>
                </c:pt>
                <c:pt idx="10">
                  <c:v>13</c:v>
                </c:pt>
                <c:pt idx="12">
                  <c:v>18</c:v>
                </c:pt>
                <c:pt idx="13">
                  <c:v>17</c:v>
                </c:pt>
                <c:pt idx="15">
                  <c:v>18</c:v>
                </c:pt>
                <c:pt idx="16">
                  <c:v>3</c:v>
                </c:pt>
                <c:pt idx="18">
                  <c:v>16</c:v>
                </c:pt>
                <c:pt idx="19">
                  <c:v>62</c:v>
                </c:pt>
                <c:pt idx="21">
                  <c:v>16</c:v>
                </c:pt>
                <c:pt idx="22">
                  <c:v>23</c:v>
                </c:pt>
                <c:pt idx="24">
                  <c:v>15</c:v>
                </c:pt>
                <c:pt idx="25">
                  <c:v>38</c:v>
                </c:pt>
                <c:pt idx="27">
                  <c:v>14</c:v>
                </c:pt>
                <c:pt idx="28">
                  <c:v>54</c:v>
                </c:pt>
                <c:pt idx="30">
                  <c:v>14</c:v>
                </c:pt>
                <c:pt idx="31">
                  <c:v>7</c:v>
                </c:pt>
                <c:pt idx="33">
                  <c:v>13</c:v>
                </c:pt>
                <c:pt idx="34">
                  <c:v>7</c:v>
                </c:pt>
                <c:pt idx="36">
                  <c:v>12</c:v>
                </c:pt>
                <c:pt idx="37">
                  <c:v>13</c:v>
                </c:pt>
                <c:pt idx="39">
                  <c:v>11</c:v>
                </c:pt>
                <c:pt idx="40">
                  <c:v>39</c:v>
                </c:pt>
                <c:pt idx="42">
                  <c:v>11</c:v>
                </c:pt>
                <c:pt idx="43">
                  <c:v>10</c:v>
                </c:pt>
                <c:pt idx="45">
                  <c:v>10</c:v>
                </c:pt>
                <c:pt idx="46">
                  <c:v>8</c:v>
                </c:pt>
                <c:pt idx="48">
                  <c:v>9</c:v>
                </c:pt>
                <c:pt idx="49">
                  <c:v>15</c:v>
                </c:pt>
                <c:pt idx="51">
                  <c:v>6</c:v>
                </c:pt>
                <c:pt idx="52">
                  <c:v>75</c:v>
                </c:pt>
                <c:pt idx="54">
                  <c:v>6</c:v>
                </c:pt>
                <c:pt idx="55">
                  <c:v>7</c:v>
                </c:pt>
                <c:pt idx="57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816F-4595-962C-91CB2B39A7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54625408"/>
        <c:axId val="354623112"/>
      </c:barChart>
      <c:catAx>
        <c:axId val="354625408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4623112"/>
        <c:crosses val="autoZero"/>
        <c:auto val="1"/>
        <c:lblAlgn val="ctr"/>
        <c:lblOffset val="100"/>
        <c:noMultiLvlLbl val="0"/>
      </c:catAx>
      <c:valAx>
        <c:axId val="354623112"/>
        <c:scaling>
          <c:orientation val="minMax"/>
        </c:scaling>
        <c:delete val="0"/>
        <c:axPos val="t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4625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ED7D3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HCP Q704'!$B$3:$B$13</c:f>
              <c:strCache>
                <c:ptCount val="11"/>
                <c:pt idx="0">
                  <c:v>Information from a healthcare provider</c:v>
                </c:pt>
                <c:pt idx="1">
                  <c:v>Dietitian or nutritionist (non-physician)</c:v>
                </c:pt>
                <c:pt idx="2">
                  <c:v>The internet (Google, social media, websites)</c:v>
                </c:pt>
                <c:pt idx="3">
                  <c:v>Family and friends</c:v>
                </c:pt>
                <c:pt idx="4">
                  <c:v>Books or magazines</c:v>
                </c:pt>
                <c:pt idx="5">
                  <c:v>Weight loss programs</c:v>
                </c:pt>
                <c:pt idx="6">
                  <c:v>Smartphone apps</c:v>
                </c:pt>
                <c:pt idx="7">
                  <c:v>Television programs</c:v>
                </c:pt>
                <c:pt idx="8">
                  <c:v>Wellness coach or personal trainer</c:v>
                </c:pt>
                <c:pt idx="9">
                  <c:v>Peer support group</c:v>
                </c:pt>
                <c:pt idx="10">
                  <c:v>None of the above </c:v>
                </c:pt>
              </c:strCache>
            </c:strRef>
          </c:cat>
          <c:val>
            <c:numRef>
              <c:f>'HCP Q704'!$C$3:$C$13</c:f>
              <c:numCache>
                <c:formatCode>0</c:formatCode>
                <c:ptCount val="11"/>
                <c:pt idx="0">
                  <c:v>46</c:v>
                </c:pt>
                <c:pt idx="1">
                  <c:v>31</c:v>
                </c:pt>
                <c:pt idx="2">
                  <c:v>30</c:v>
                </c:pt>
                <c:pt idx="3">
                  <c:v>27</c:v>
                </c:pt>
                <c:pt idx="4">
                  <c:v>20</c:v>
                </c:pt>
                <c:pt idx="5">
                  <c:v>18</c:v>
                </c:pt>
                <c:pt idx="6">
                  <c:v>14</c:v>
                </c:pt>
                <c:pt idx="7">
                  <c:v>8</c:v>
                </c:pt>
                <c:pt idx="8">
                  <c:v>7</c:v>
                </c:pt>
                <c:pt idx="9">
                  <c:v>3</c:v>
                </c:pt>
                <c:pt idx="10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4C-4866-AE7A-A42F6EF6348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2"/>
        <c:axId val="646248816"/>
        <c:axId val="646244552"/>
      </c:barChart>
      <c:catAx>
        <c:axId val="646248816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6244552"/>
        <c:crosses val="autoZero"/>
        <c:auto val="1"/>
        <c:lblAlgn val="ctr"/>
        <c:lblOffset val="100"/>
        <c:noMultiLvlLbl val="0"/>
      </c:catAx>
      <c:valAx>
        <c:axId val="646244552"/>
        <c:scaling>
          <c:orientation val="minMax"/>
          <c:max val="50"/>
        </c:scaling>
        <c:delete val="0"/>
        <c:axPos val="t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624881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2">
  <a:schemeClr val="accent2"/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330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830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25642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D0BA5-38F4-45A9-B49B-4014FC45BE74}" type="datetime1">
              <a:rPr lang="en-GB" smtClean="0"/>
              <a:t>13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429250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5C49F-AF8F-44B9-A6F9-E7211F3DBFF4}" type="datetime1">
              <a:rPr lang="en-GB" smtClean="0"/>
              <a:t>13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80634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2ED22-C47B-4253-BCA9-3FBBB21051EB}" type="datetime1">
              <a:rPr lang="en-GB" smtClean="0"/>
              <a:t>13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838391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27E7-2B5B-4DE0-833A-6BB648AA0CDC}" type="datetime1">
              <a:rPr lang="en-GB" smtClean="0"/>
              <a:t>13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721187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39E77-ED20-44AC-9A82-9B6830976575}" type="datetime1">
              <a:rPr lang="en-GB" smtClean="0"/>
              <a:t>13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198140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A234E-8CDF-4396-BDC7-321B15BEEC6E}" type="datetime1">
              <a:rPr lang="en-GB" smtClean="0"/>
              <a:t>13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4357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AEF25-F757-41A4-9455-84C75B87E2BC}" type="datetime1">
              <a:rPr lang="en-GB" smtClean="0"/>
              <a:t>13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313732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6BFE-8363-4DBB-BEBC-CB6F9EAFE889}" type="datetime1">
              <a:rPr lang="en-GB" smtClean="0"/>
              <a:t>13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2674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56284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55DCA-7EFA-43FB-889B-5990D7FF104D}" type="datetime1">
              <a:rPr lang="en-GB" smtClean="0"/>
              <a:t>13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598121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7EFB7-71D1-4548-9C23-BCFF311E96FD}" type="datetime1">
              <a:rPr lang="en-GB" smtClean="0"/>
              <a:t>13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951793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2B1CEF-1A84-4E89-8B99-4287D1E24067}" type="datetime1">
              <a:rPr lang="en-GB" smtClean="0"/>
              <a:t>13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2531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462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964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69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500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114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990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78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A60E-DD6B-4B5B-8D01-97D2C90F207A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29E7AF-7980-4DEB-AAF3-40C7AB2FA7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117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02A9F-B94E-4793-B8FA-ABD51A55B4CF}" type="datetime1">
              <a:rPr lang="en-GB" smtClean="0"/>
              <a:t>13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7965FB-4606-4DF0-949C-680CC152FB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7437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38437888-9D55-4347-92F8-47737BEF4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A7965FB-4606-4DF0-949C-680CC152FBBF}" type="slidenum">
              <a:rPr kumimoji="0" lang="en-GB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GB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" name="Title 3">
            <a:extLst>
              <a:ext uri="{FF2B5EF4-FFF2-40B4-BE49-F238E27FC236}">
                <a16:creationId xmlns:a16="http://schemas.microsoft.com/office/drawing/2014/main" id="{B35601D7-202E-48F4-A794-8719305F8B2E}"/>
              </a:ext>
            </a:extLst>
          </p:cNvPr>
          <p:cNvSpPr txBox="1">
            <a:spLocks/>
          </p:cNvSpPr>
          <p:nvPr/>
        </p:nvSpPr>
        <p:spPr>
          <a:xfrm>
            <a:off x="660172" y="48435"/>
            <a:ext cx="5915025" cy="5641166"/>
          </a:xfrm>
          <a:prstGeom prst="rect">
            <a:avLst/>
          </a:prstGeom>
        </p:spPr>
        <p:txBody>
          <a:bodyPr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kumimoji="0" lang="en-GB" sz="3300" b="1" i="0" u="none" strike="noStrike" kern="1200" cap="none" spc="0" normalizeH="0" baseline="0" noProof="0" dirty="0">
                <a:ln>
                  <a:noFill/>
                </a:ln>
                <a:solidFill>
                  <a:srgbClr val="5B9BD5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Supplementary file</a:t>
            </a:r>
            <a:br>
              <a:rPr kumimoji="0" lang="en-GB" sz="3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</a:br>
            <a:br>
              <a:rPr kumimoji="0" lang="en-GB" sz="3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</a:b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Supplement for: </a:t>
            </a:r>
            <a:r>
              <a:rPr lang="en-GB" sz="2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avier Salvador , </a:t>
            </a: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et al. </a:t>
            </a:r>
            <a:r>
              <a:rPr lang="en-GB" sz="2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ptions, attitudes and barriers to obesity management in Spain: Results from the Spanish cohort of the international ACTION-IO observation study</a:t>
            </a:r>
            <a:br>
              <a:rPr kumimoji="0" lang="en-GB" sz="3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</a:br>
            <a:endParaRPr kumimoji="0" lang="en-GB" sz="33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3879187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extBox 75">
            <a:extLst>
              <a:ext uri="{FF2B5EF4-FFF2-40B4-BE49-F238E27FC236}">
                <a16:creationId xmlns:a16="http://schemas.microsoft.com/office/drawing/2014/main" id="{02EE97CA-9313-4F86-ACE7-41B3D8545E53}"/>
              </a:ext>
            </a:extLst>
          </p:cNvPr>
          <p:cNvSpPr txBox="1"/>
          <p:nvPr/>
        </p:nvSpPr>
        <p:spPr>
          <a:xfrm>
            <a:off x="150667" y="111358"/>
            <a:ext cx="631871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ssessing the impact of health conditions on overall health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roportion of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w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and HCPs rating the impact of health conditions. HCPs = green;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w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= orange. 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PD, chronic obstructive pulmonary disease; HCP, healthcare professional;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w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people with obesity.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1E6522A2-9A9D-4B73-A048-7DA5EAF58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GB" dirty="0"/>
              <a:t>8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458730B-6DAF-4FCC-9D7D-B67EA61E8A37}"/>
              </a:ext>
            </a:extLst>
          </p:cNvPr>
          <p:cNvGrpSpPr/>
          <p:nvPr/>
        </p:nvGrpSpPr>
        <p:grpSpPr>
          <a:xfrm>
            <a:off x="286792" y="765245"/>
            <a:ext cx="5763345" cy="1759591"/>
            <a:chOff x="286792" y="765245"/>
            <a:chExt cx="5763345" cy="1759591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93712DE3-758C-4C28-BFA3-8C45649EBAB1}"/>
                </a:ext>
              </a:extLst>
            </p:cNvPr>
            <p:cNvGrpSpPr/>
            <p:nvPr/>
          </p:nvGrpSpPr>
          <p:grpSpPr>
            <a:xfrm>
              <a:off x="4490613" y="1303250"/>
              <a:ext cx="1559524" cy="581718"/>
              <a:chOff x="4502197" y="1191245"/>
              <a:chExt cx="1559524" cy="581718"/>
            </a:xfrm>
          </p:grpSpPr>
          <p:sp>
            <p:nvSpPr>
              <p:cNvPr id="65" name="Rectangle 64">
                <a:extLst>
                  <a:ext uri="{FF2B5EF4-FFF2-40B4-BE49-F238E27FC236}">
                    <a16:creationId xmlns:a16="http://schemas.microsoft.com/office/drawing/2014/main" id="{D6C72B84-4E19-49F9-85D5-EE6830E82CC9}"/>
                  </a:ext>
                </a:extLst>
              </p:cNvPr>
              <p:cNvSpPr/>
              <p:nvPr/>
            </p:nvSpPr>
            <p:spPr>
              <a:xfrm>
                <a:off x="4502197" y="1267296"/>
                <a:ext cx="52330" cy="52330"/>
              </a:xfrm>
              <a:prstGeom prst="rect">
                <a:avLst/>
              </a:prstGeom>
              <a:solidFill>
                <a:schemeClr val="accent2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Rectangle 65">
                <a:extLst>
                  <a:ext uri="{FF2B5EF4-FFF2-40B4-BE49-F238E27FC236}">
                    <a16:creationId xmlns:a16="http://schemas.microsoft.com/office/drawing/2014/main" id="{F187BF3D-6D8A-4DDA-BBAE-5330625D1B49}"/>
                  </a:ext>
                </a:extLst>
              </p:cNvPr>
              <p:cNvSpPr/>
              <p:nvPr/>
            </p:nvSpPr>
            <p:spPr>
              <a:xfrm>
                <a:off x="4587618" y="1267296"/>
                <a:ext cx="52330" cy="52330"/>
              </a:xfrm>
              <a:prstGeom prst="rect">
                <a:avLst/>
              </a:prstGeom>
              <a:solidFill>
                <a:schemeClr val="accent6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tangle 66">
                <a:extLst>
                  <a:ext uri="{FF2B5EF4-FFF2-40B4-BE49-F238E27FC236}">
                    <a16:creationId xmlns:a16="http://schemas.microsoft.com/office/drawing/2014/main" id="{12E96CF3-175A-479C-AAAB-6BF616D7DF71}"/>
                  </a:ext>
                </a:extLst>
              </p:cNvPr>
              <p:cNvSpPr/>
              <p:nvPr/>
            </p:nvSpPr>
            <p:spPr>
              <a:xfrm>
                <a:off x="4502197" y="1456892"/>
                <a:ext cx="52330" cy="5233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Rectangle 67">
                <a:extLst>
                  <a:ext uri="{FF2B5EF4-FFF2-40B4-BE49-F238E27FC236}">
                    <a16:creationId xmlns:a16="http://schemas.microsoft.com/office/drawing/2014/main" id="{83EA7587-8CA0-4931-8FB9-B4CA160A3DE6}"/>
                  </a:ext>
                </a:extLst>
              </p:cNvPr>
              <p:cNvSpPr/>
              <p:nvPr/>
            </p:nvSpPr>
            <p:spPr>
              <a:xfrm>
                <a:off x="4587618" y="1456892"/>
                <a:ext cx="52330" cy="5233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Rectangle 68">
                <a:extLst>
                  <a:ext uri="{FF2B5EF4-FFF2-40B4-BE49-F238E27FC236}">
                    <a16:creationId xmlns:a16="http://schemas.microsoft.com/office/drawing/2014/main" id="{09755774-F373-4453-9CA9-4493AC5D4785}"/>
                  </a:ext>
                </a:extLst>
              </p:cNvPr>
              <p:cNvSpPr/>
              <p:nvPr/>
            </p:nvSpPr>
            <p:spPr>
              <a:xfrm>
                <a:off x="4502197" y="1647761"/>
                <a:ext cx="52330" cy="5233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F395948D-F903-482A-A27E-F42F236DF0E9}"/>
                  </a:ext>
                </a:extLst>
              </p:cNvPr>
              <p:cNvSpPr/>
              <p:nvPr/>
            </p:nvSpPr>
            <p:spPr>
              <a:xfrm>
                <a:off x="4587618" y="1647761"/>
                <a:ext cx="52330" cy="52330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19DAAF43-B427-4557-AEB6-14B3B862B602}"/>
                  </a:ext>
                </a:extLst>
              </p:cNvPr>
              <p:cNvSpPr txBox="1"/>
              <p:nvPr/>
            </p:nvSpPr>
            <p:spPr>
              <a:xfrm>
                <a:off x="4628315" y="1572908"/>
                <a:ext cx="110158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ittle impact (bottom 2)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98D16DC2-CF55-4E35-B7D6-6411DE2E14B2}"/>
                  </a:ext>
                </a:extLst>
              </p:cNvPr>
              <p:cNvSpPr txBox="1"/>
              <p:nvPr/>
            </p:nvSpPr>
            <p:spPr>
              <a:xfrm>
                <a:off x="4628315" y="1382077"/>
                <a:ext cx="14334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eutral/some impact (middle 1)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A6056696-58BF-48C5-BD26-C61C4F8C628C}"/>
                  </a:ext>
                </a:extLst>
              </p:cNvPr>
              <p:cNvSpPr txBox="1"/>
              <p:nvPr/>
            </p:nvSpPr>
            <p:spPr>
              <a:xfrm>
                <a:off x="4628315" y="1191245"/>
                <a:ext cx="99097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arge impact (top 2)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588010D-FA55-47DA-8DFB-AAE187EB0875}"/>
                </a:ext>
              </a:extLst>
            </p:cNvPr>
            <p:cNvSpPr txBox="1"/>
            <p:nvPr/>
          </p:nvSpPr>
          <p:spPr>
            <a:xfrm>
              <a:off x="551534" y="2217059"/>
              <a:ext cx="53671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wO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familiar with condition, </a:t>
              </a:r>
              <a:r>
                <a:rPr lang="en-US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 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= </a:t>
              </a:r>
              <a:r>
                <a:rPr lang="pt-B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500; HCPs, </a:t>
              </a:r>
              <a:r>
                <a:rPr lang="pt-BR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pt-B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= 306; Q405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;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r</a:t>
              </a:r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ted</a:t>
              </a:r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 on a scale where 1 = very little impact, 5 = extreme impact.</a:t>
              </a:r>
            </a:p>
            <a:p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5E100E74-93B5-4EBD-A649-6EDDFAF597CE}"/>
                </a:ext>
              </a:extLst>
            </p:cNvPr>
            <p:cNvSpPr/>
            <p:nvPr/>
          </p:nvSpPr>
          <p:spPr>
            <a:xfrm>
              <a:off x="551534" y="2050135"/>
              <a:ext cx="3677082" cy="1668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A1A8731-8912-4DC3-ADD1-F327A1477DF8}"/>
                </a:ext>
              </a:extLst>
            </p:cNvPr>
            <p:cNvSpPr txBox="1"/>
            <p:nvPr/>
          </p:nvSpPr>
          <p:spPr>
            <a:xfrm>
              <a:off x="759746" y="2017535"/>
              <a:ext cx="4892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Obesity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C8E91AA-455D-4796-B7B8-06F3D647720B}"/>
                </a:ext>
              </a:extLst>
            </p:cNvPr>
            <p:cNvSpPr txBox="1"/>
            <p:nvPr/>
          </p:nvSpPr>
          <p:spPr>
            <a:xfrm>
              <a:off x="1466901" y="2017535"/>
              <a:ext cx="4443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Stroke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0C7877F-7FF8-4472-9063-126595002B9D}"/>
                </a:ext>
              </a:extLst>
            </p:cNvPr>
            <p:cNvSpPr txBox="1"/>
            <p:nvPr/>
          </p:nvSpPr>
          <p:spPr>
            <a:xfrm>
              <a:off x="2233641" y="2017535"/>
              <a:ext cx="5373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Diabetes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8B9FB38-D553-42D0-8806-04BAE23DEB27}"/>
                </a:ext>
              </a:extLst>
            </p:cNvPr>
            <p:cNvSpPr txBox="1"/>
            <p:nvPr/>
          </p:nvSpPr>
          <p:spPr>
            <a:xfrm>
              <a:off x="2954091" y="2017535"/>
              <a:ext cx="47320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Cancer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82494E1-EB9D-4139-B044-2812C01566FB}"/>
                </a:ext>
              </a:extLst>
            </p:cNvPr>
            <p:cNvSpPr txBox="1"/>
            <p:nvPr/>
          </p:nvSpPr>
          <p:spPr>
            <a:xfrm>
              <a:off x="3689617" y="2017535"/>
              <a:ext cx="4427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COPD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EA1EE705-9A0E-49EA-91E4-F45A6314D20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39868" y="1860551"/>
              <a:ext cx="348874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54D7ED32-2AAA-4834-B878-A620406A46E5}"/>
                </a:ext>
              </a:extLst>
            </p:cNvPr>
            <p:cNvSpPr txBox="1"/>
            <p:nvPr/>
          </p:nvSpPr>
          <p:spPr>
            <a:xfrm rot="16200000">
              <a:off x="-289339" y="1341376"/>
              <a:ext cx="1352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Percentage of respondents</a:t>
              </a:r>
            </a:p>
          </p:txBody>
        </p:sp>
        <p:graphicFrame>
          <p:nvGraphicFramePr>
            <p:cNvPr id="36" name="Chart 35">
              <a:extLst>
                <a:ext uri="{FF2B5EF4-FFF2-40B4-BE49-F238E27FC236}">
                  <a16:creationId xmlns:a16="http://schemas.microsoft.com/office/drawing/2014/main" id="{598645AF-363F-4599-9D5B-16BF5CE2BDC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74126667"/>
                </p:ext>
              </p:extLst>
            </p:nvPr>
          </p:nvGraphicFramePr>
          <p:xfrm>
            <a:off x="463375" y="901881"/>
            <a:ext cx="3827886" cy="1098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5717966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64573D70-2006-42FC-95DD-B320BEDCB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A7965FB-4606-4DF0-949C-680CC152FBBF}" type="slidenum">
              <a:rPr kumimoji="0" lang="en-GB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GB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D88E2771-335D-4A45-9C09-BA5F0324FA7A}"/>
              </a:ext>
            </a:extLst>
          </p:cNvPr>
          <p:cNvGrpSpPr/>
          <p:nvPr/>
        </p:nvGrpSpPr>
        <p:grpSpPr>
          <a:xfrm>
            <a:off x="-2072529" y="866907"/>
            <a:ext cx="9690102" cy="7780241"/>
            <a:chOff x="-2072529" y="866907"/>
            <a:chExt cx="9690102" cy="778024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4E04E5A-8879-4939-9451-C76CA2116E39}"/>
                </a:ext>
              </a:extLst>
            </p:cNvPr>
            <p:cNvGrpSpPr/>
            <p:nvPr/>
          </p:nvGrpSpPr>
          <p:grpSpPr>
            <a:xfrm>
              <a:off x="-2072529" y="866907"/>
              <a:ext cx="9690102" cy="7780241"/>
              <a:chOff x="-2072529" y="866907"/>
              <a:chExt cx="9690102" cy="7780241"/>
            </a:xfrm>
          </p:grpSpPr>
          <p:graphicFrame>
            <p:nvGraphicFramePr>
              <p:cNvPr id="15" name="Chart 14">
                <a:extLst>
                  <a:ext uri="{FF2B5EF4-FFF2-40B4-BE49-F238E27FC236}">
                    <a16:creationId xmlns:a16="http://schemas.microsoft.com/office/drawing/2014/main" id="{D6D96479-593F-48CB-B619-B80BC41C864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74359062"/>
                  </p:ext>
                </p:extLst>
              </p:nvPr>
            </p:nvGraphicFramePr>
            <p:xfrm>
              <a:off x="-2072529" y="866907"/>
              <a:ext cx="9690102" cy="756875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8" name="TOSS">
                <a:extLst>
                  <a:ext uri="{FF2B5EF4-FFF2-40B4-BE49-F238E27FC236}">
                    <a16:creationId xmlns:a16="http://schemas.microsoft.com/office/drawing/2014/main" id="{DCADE239-D935-412F-BA73-4C38CA85F03E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26949" y="8155928"/>
                <a:ext cx="5820060" cy="491220"/>
              </a:xfrm>
              <a:prstGeom prst="rect">
                <a:avLst/>
              </a:prstGeom>
            </p:spPr>
            <p:txBody>
              <a:bodyPr vert="horz" lIns="91440" tIns="45720" rIns="91440" bIns="45720"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9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wO, </a:t>
                </a:r>
                <a:r>
                  <a:rPr kumimoji="0" lang="en-US" sz="7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n </a:t>
                </a:r>
                <a:r>
                  <a:rPr kumimoji="0" lang="en-US" sz="7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= 1500;     HCPs, </a:t>
                </a:r>
                <a:r>
                  <a:rPr kumimoji="0" lang="en-US" sz="7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n </a:t>
                </a:r>
                <a:r>
                  <a:rPr kumimoji="0" lang="en-US" sz="7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= 306; Q770/708</a:t>
                </a:r>
                <a:endParaRPr kumimoji="0" lang="en-US" sz="7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6">
                <a:extLst>
                  <a:ext uri="{FF2B5EF4-FFF2-40B4-BE49-F238E27FC236}">
                    <a16:creationId xmlns:a16="http://schemas.microsoft.com/office/drawing/2014/main" id="{8BEE1159-250B-4660-A0E5-D26F37CE7D2A}"/>
                  </a:ext>
                </a:extLst>
              </p:cNvPr>
              <p:cNvSpPr txBox="1"/>
              <p:nvPr/>
            </p:nvSpPr>
            <p:spPr>
              <a:xfrm>
                <a:off x="3812432" y="872321"/>
                <a:ext cx="3203559" cy="215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ercentage of respondents selecting answer as 1 of top 5</a:t>
                </a:r>
              </a:p>
            </p:txBody>
          </p:sp>
        </p:grp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CEF1F26B-44F7-42FF-9B2D-FE1EF818F086}"/>
                </a:ext>
              </a:extLst>
            </p:cNvPr>
            <p:cNvSpPr/>
            <p:nvPr/>
          </p:nvSpPr>
          <p:spPr>
            <a:xfrm>
              <a:off x="2448397" y="8374125"/>
              <a:ext cx="54711" cy="54711"/>
            </a:xfrm>
            <a:prstGeom prst="rect">
              <a:avLst/>
            </a:prstGeom>
            <a:solidFill>
              <a:schemeClr val="accent2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D7A8CAA4-A10D-4EAD-B9B7-24C44AFD15B3}"/>
                </a:ext>
              </a:extLst>
            </p:cNvPr>
            <p:cNvSpPr/>
            <p:nvPr/>
          </p:nvSpPr>
          <p:spPr>
            <a:xfrm>
              <a:off x="3215539" y="8374125"/>
              <a:ext cx="54711" cy="54711"/>
            </a:xfrm>
            <a:prstGeom prst="rect">
              <a:avLst/>
            </a:prstGeom>
            <a:solidFill>
              <a:schemeClr val="accent6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26CD4788-67AB-447B-B7E3-4D9A6B87DAEB}"/>
              </a:ext>
            </a:extLst>
          </p:cNvPr>
          <p:cNvSpPr txBox="1"/>
          <p:nvPr/>
        </p:nvSpPr>
        <p:spPr>
          <a:xfrm>
            <a:off x="150667" y="111358"/>
            <a:ext cx="631871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asons for not discussing weight with an HCP (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w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orange) or patient (HCPs, green).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spondents selected their top 5 reasons from the list of options.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CP, healthcare professional;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w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people with obesity.</a:t>
            </a:r>
          </a:p>
        </p:txBody>
      </p:sp>
    </p:spTree>
    <p:extLst>
      <p:ext uri="{BB962C8B-B14F-4D97-AF65-F5344CB8AC3E}">
        <p14:creationId xmlns:p14="http://schemas.microsoft.com/office/powerpoint/2010/main" val="31040869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2749AB6E-14D1-4F5F-84B2-B3065B2DF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A7965FB-4606-4DF0-949C-680CC152FBBF}" type="slidenum">
              <a:rPr kumimoji="0" lang="en-GB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GB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E8D9FC6E-94B2-4B39-B1E0-663887F6FC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1675865"/>
              </p:ext>
            </p:extLst>
          </p:nvPr>
        </p:nvGraphicFramePr>
        <p:xfrm>
          <a:off x="337387" y="1218077"/>
          <a:ext cx="6183225" cy="44914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B08CF973-AF36-45BB-991C-DF430206E9FB}"/>
              </a:ext>
            </a:extLst>
          </p:cNvPr>
          <p:cNvSpPr/>
          <p:nvPr/>
        </p:nvSpPr>
        <p:spPr>
          <a:xfrm>
            <a:off x="2400462" y="5735669"/>
            <a:ext cx="119776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wO</a:t>
            </a:r>
            <a:r>
              <a: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, </a:t>
            </a:r>
            <a:r>
              <a:rPr kumimoji="0" lang="en-US" sz="8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</a:t>
            </a:r>
            <a:r>
              <a: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= 1500; Q600</a:t>
            </a:r>
            <a:endParaRPr kumimoji="0" lang="en-US" sz="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63495AB-1001-4EFE-8F62-6B1FF10356B0}"/>
              </a:ext>
            </a:extLst>
          </p:cNvPr>
          <p:cNvSpPr/>
          <p:nvPr/>
        </p:nvSpPr>
        <p:spPr>
          <a:xfrm>
            <a:off x="2304126" y="630620"/>
            <a:ext cx="29241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ources of information for managing weight </a:t>
            </a:r>
            <a:endParaRPr kumimoji="0" 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6724895-9845-49AB-A294-1D0BB906B81B}"/>
              </a:ext>
            </a:extLst>
          </p:cNvPr>
          <p:cNvSpPr/>
          <p:nvPr/>
        </p:nvSpPr>
        <p:spPr>
          <a:xfrm>
            <a:off x="2987572" y="1022627"/>
            <a:ext cx="265329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ources of information for managing weight (%) </a:t>
            </a:r>
            <a:endParaRPr kumimoji="0" 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E0FD70A-AFE1-4A57-AE0A-C1C6092958DE}"/>
              </a:ext>
            </a:extLst>
          </p:cNvPr>
          <p:cNvSpPr txBox="1"/>
          <p:nvPr/>
        </p:nvSpPr>
        <p:spPr>
          <a:xfrm>
            <a:off x="150667" y="111358"/>
            <a:ext cx="6318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ources of information used by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w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for managing weight.</a:t>
            </a:r>
          </a:p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w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people with obesity.</a:t>
            </a:r>
          </a:p>
        </p:txBody>
      </p:sp>
    </p:spTree>
    <p:extLst>
      <p:ext uri="{BB962C8B-B14F-4D97-AF65-F5344CB8AC3E}">
        <p14:creationId xmlns:p14="http://schemas.microsoft.com/office/powerpoint/2010/main" val="835664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</TotalTime>
  <Words>229</Words>
  <Application>Microsoft Office PowerPoint</Application>
  <PresentationFormat>A4 Paper (210x297 mm)</PresentationFormat>
  <Paragraphs>2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uan Paul (SciM)</dc:creator>
  <cp:lastModifiedBy>Bhavika Modasia (AS)</cp:lastModifiedBy>
  <cp:revision>20</cp:revision>
  <dcterms:created xsi:type="dcterms:W3CDTF">2019-11-29T14:35:05Z</dcterms:created>
  <dcterms:modified xsi:type="dcterms:W3CDTF">2020-07-13T15:02:05Z</dcterms:modified>
</cp:coreProperties>
</file>